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139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6910-EFC5-4025-A180-B37208AE07D8}" type="datetimeFigureOut">
              <a:rPr lang="en-US" smtClean="0"/>
              <a:t>1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EC272-D086-4EB4-8F45-C8C52A5A57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5748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6910-EFC5-4025-A180-B37208AE07D8}" type="datetimeFigureOut">
              <a:rPr lang="en-US" smtClean="0"/>
              <a:t>1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EC272-D086-4EB4-8F45-C8C52A5A57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86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6910-EFC5-4025-A180-B37208AE07D8}" type="datetimeFigureOut">
              <a:rPr lang="en-US" smtClean="0"/>
              <a:t>1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EC272-D086-4EB4-8F45-C8C52A5A57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753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6910-EFC5-4025-A180-B37208AE07D8}" type="datetimeFigureOut">
              <a:rPr lang="en-US" smtClean="0"/>
              <a:t>1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EC272-D086-4EB4-8F45-C8C52A5A57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266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6910-EFC5-4025-A180-B37208AE07D8}" type="datetimeFigureOut">
              <a:rPr lang="en-US" smtClean="0"/>
              <a:t>1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EC272-D086-4EB4-8F45-C8C52A5A57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47562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6910-EFC5-4025-A180-B37208AE07D8}" type="datetimeFigureOut">
              <a:rPr lang="en-US" smtClean="0"/>
              <a:t>1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EC272-D086-4EB4-8F45-C8C52A5A57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456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6910-EFC5-4025-A180-B37208AE07D8}" type="datetimeFigureOut">
              <a:rPr lang="en-US" smtClean="0"/>
              <a:t>1/1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EC272-D086-4EB4-8F45-C8C52A5A57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563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6910-EFC5-4025-A180-B37208AE07D8}" type="datetimeFigureOut">
              <a:rPr lang="en-US" smtClean="0"/>
              <a:t>1/1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EC272-D086-4EB4-8F45-C8C52A5A57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547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6910-EFC5-4025-A180-B37208AE07D8}" type="datetimeFigureOut">
              <a:rPr lang="en-US" smtClean="0"/>
              <a:t>1/1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EC272-D086-4EB4-8F45-C8C52A5A57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823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6910-EFC5-4025-A180-B37208AE07D8}" type="datetimeFigureOut">
              <a:rPr lang="en-US" smtClean="0"/>
              <a:t>1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EC272-D086-4EB4-8F45-C8C52A5A57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4398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6910-EFC5-4025-A180-B37208AE07D8}" type="datetimeFigureOut">
              <a:rPr lang="en-US" smtClean="0"/>
              <a:t>1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EC272-D086-4EB4-8F45-C8C52A5A57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282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8E6910-EFC5-4025-A180-B37208AE07D8}" type="datetimeFigureOut">
              <a:rPr lang="en-US" smtClean="0"/>
              <a:t>1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5EC272-D086-4EB4-8F45-C8C52A5A57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727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3A867D7-05D8-4881-B51B-9086258C73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9597" y="178488"/>
            <a:ext cx="8624806" cy="579437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F23C1AE-96A9-4F9C-A740-90A3401DAE9F}"/>
              </a:ext>
            </a:extLst>
          </p:cNvPr>
          <p:cNvSpPr txBox="1"/>
          <p:nvPr/>
        </p:nvSpPr>
        <p:spPr>
          <a:xfrm>
            <a:off x="250805" y="6069574"/>
            <a:ext cx="862480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S1</a:t>
            </a:r>
            <a:r>
              <a:rPr lang="en-US" dirty="0"/>
              <a:t>. Derive a stable a line of flies that are homozygous for the Eaat1-GAL4 driver and UAS-NICD (i.e., the EN-line).</a:t>
            </a:r>
          </a:p>
        </p:txBody>
      </p:sp>
    </p:spTree>
    <p:extLst>
      <p:ext uri="{BB962C8B-B14F-4D97-AF65-F5344CB8AC3E}">
        <p14:creationId xmlns:p14="http://schemas.microsoft.com/office/powerpoint/2010/main" val="33496808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 Zhou</dc:creator>
  <cp:lastModifiedBy>Dan Zhou</cp:lastModifiedBy>
  <cp:revision>1</cp:revision>
  <dcterms:created xsi:type="dcterms:W3CDTF">2021-01-20T01:18:19Z</dcterms:created>
  <dcterms:modified xsi:type="dcterms:W3CDTF">2021-01-20T01:20:31Z</dcterms:modified>
</cp:coreProperties>
</file>